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2" r:id="rId2"/>
    <p:sldId id="360" r:id="rId3"/>
    <p:sldId id="267" r:id="rId4"/>
    <p:sldId id="340" r:id="rId5"/>
    <p:sldId id="350" r:id="rId6"/>
    <p:sldId id="351" r:id="rId7"/>
    <p:sldId id="264" r:id="rId8"/>
    <p:sldId id="353" r:id="rId9"/>
    <p:sldId id="354" r:id="rId10"/>
    <p:sldId id="355" r:id="rId11"/>
    <p:sldId id="356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02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">
            <a:extLst>
              <a:ext uri="{FF2B5EF4-FFF2-40B4-BE49-F238E27FC236}">
                <a16:creationId xmlns:a16="http://schemas.microsoft.com/office/drawing/2014/main" id="{0F992118-9E2E-4E50-92D9-991F1D0446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800" y="228600"/>
            <a:ext cx="781050" cy="296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D8ACBA3-979B-4212-A9B0-1CCF6AED73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2811062"/>
              </p:ext>
            </p:extLst>
          </p:nvPr>
        </p:nvGraphicFramePr>
        <p:xfrm>
          <a:off x="359569" y="1066800"/>
          <a:ext cx="8424862" cy="3200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096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Multi-</a:t>
                      </a:r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epitope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 antigen 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No.</a:t>
                      </a:r>
                      <a:r>
                        <a:rPr lang="en-IN" sz="9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of residues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Isoelectric point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Mol Wt. (</a:t>
                      </a:r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kDa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Instability Index (II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Aliphatic Index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GRAVY Score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Secondary structure by PSIPRED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Antigenicity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 by </a:t>
                      </a:r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Vexijen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 v2.0 (T=0.4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Allergenicity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 by </a:t>
                      </a:r>
                      <a:r>
                        <a:rPr lang="en-IN" sz="900" b="1" dirty="0" err="1">
                          <a:latin typeface="Times New Roman" pitchFamily="18" charset="0"/>
                          <a:cs typeface="Times New Roman" pitchFamily="18" charset="0"/>
                        </a:rPr>
                        <a:t>Allertop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 v.2.0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RBD of spike protein (B- and T-cell epitopes)</a:t>
                      </a:r>
                      <a:endParaRPr lang="en-US" sz="9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325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9.64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34.6621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Stable (</a:t>
                      </a:r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31.94</a:t>
                      </a:r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64.49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-0.316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17.54% Helix, 24.31% Strand and 58.15% Coil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Antigen (</a:t>
                      </a:r>
                      <a:r>
                        <a:rPr lang="en-US" sz="800" b="1" i="0" kern="12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7200</a:t>
                      </a:r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Non-allergen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Spike protein (</a:t>
                      </a:r>
                      <a:r>
                        <a:rPr lang="en-US" sz="900" dirty="0">
                          <a:latin typeface="Times New Roman" pitchFamily="18" charset="0"/>
                          <a:cs typeface="Times New Roman" pitchFamily="18" charset="0"/>
                        </a:rPr>
                        <a:t>B- and T-cell epitopes)</a:t>
                      </a:r>
                      <a:endParaRPr lang="en-US" sz="9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488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9.2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52.2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Stable</a:t>
                      </a:r>
                      <a:r>
                        <a:rPr lang="en-IN" sz="9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(</a:t>
                      </a:r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6</a:t>
                      </a:r>
                      <a:r>
                        <a:rPr lang="en-IN" sz="900" b="1" baseline="0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70.5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-0.31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41.39% Helix, 12.30% Strand and 46.31% Coil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Antigen (</a:t>
                      </a:r>
                      <a:r>
                        <a:rPr lang="en-US" sz="900" b="1" i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026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IN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allergen</a:t>
                      </a:r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Times New Roman" pitchFamily="18" charset="0"/>
                          <a:cs typeface="Times New Roman" pitchFamily="18" charset="0"/>
                        </a:rPr>
                        <a:t>Structural protein construct </a:t>
                      </a:r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(B- and T-cell epitopes of S, N, M and E protein)</a:t>
                      </a:r>
                      <a:endParaRPr lang="en-US" sz="9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1104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9.6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118.9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Stable (</a:t>
                      </a:r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24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82.9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-0.01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35.33% Helix, 11.96% Strand and 64.67% Coil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Antigen (</a:t>
                      </a:r>
                      <a:r>
                        <a:rPr lang="en-US" sz="900" b="1" i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258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allergen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Times New Roman" pitchFamily="18" charset="0"/>
                          <a:cs typeface="Times New Roman" pitchFamily="18" charset="0"/>
                        </a:rPr>
                        <a:t>Chimeric construct of S and N proteins (</a:t>
                      </a:r>
                      <a:r>
                        <a:rPr lang="en-IN" sz="900" dirty="0">
                          <a:latin typeface="Times New Roman" pitchFamily="18" charset="0"/>
                          <a:cs typeface="Times New Roman" pitchFamily="18" charset="0"/>
                        </a:rPr>
                        <a:t>B- and T-cell epitopes of S and N)</a:t>
                      </a:r>
                      <a:endParaRPr lang="en-US" sz="9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endParaRPr lang="en-US" sz="9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839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9.8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89.5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Unstable</a:t>
                      </a:r>
                      <a:r>
                        <a:rPr lang="en-IN" sz="9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(</a:t>
                      </a:r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55</a:t>
                      </a:r>
                      <a:r>
                        <a:rPr lang="en-IN" sz="900" b="1" baseline="0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58.4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Times New Roman" pitchFamily="18" charset="0"/>
                          <a:cs typeface="Times New Roman" pitchFamily="18" charset="0"/>
                        </a:rPr>
                        <a:t>-0.53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32.78% Helix, 13.23% Strand and 67.22% Coil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Antigen (</a:t>
                      </a:r>
                      <a:r>
                        <a:rPr lang="en-US" sz="900" b="1" i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753</a:t>
                      </a:r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900" b="1" dirty="0">
                          <a:latin typeface="Times New Roman" pitchFamily="18" charset="0"/>
                          <a:cs typeface="Times New Roman" pitchFamily="18" charset="0"/>
                        </a:rPr>
                        <a:t>Non-allergen</a:t>
                      </a:r>
                      <a:endParaRPr lang="en-US" sz="9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25C45B83-8F7D-4090-88BD-2C27263B9465}"/>
              </a:ext>
            </a:extLst>
          </p:cNvPr>
          <p:cNvGrpSpPr/>
          <p:nvPr/>
        </p:nvGrpSpPr>
        <p:grpSpPr>
          <a:xfrm>
            <a:off x="533400" y="496195"/>
            <a:ext cx="8172450" cy="5392027"/>
            <a:chOff x="575853" y="71655"/>
            <a:chExt cx="10896600" cy="7189369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C163FDE-E93D-4E18-A346-9EF8E0AB1326}"/>
                </a:ext>
              </a:extLst>
            </p:cNvPr>
            <p:cNvSpPr txBox="1"/>
            <p:nvPr/>
          </p:nvSpPr>
          <p:spPr>
            <a:xfrm>
              <a:off x="575853" y="179423"/>
              <a:ext cx="44355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8BA2C87-4FB3-43B2-A5E3-6FA354581184}"/>
                </a:ext>
              </a:extLst>
            </p:cNvPr>
            <p:cNvGrpSpPr/>
            <p:nvPr/>
          </p:nvGrpSpPr>
          <p:grpSpPr>
            <a:xfrm>
              <a:off x="838388" y="71655"/>
              <a:ext cx="10634065" cy="7189369"/>
              <a:chOff x="838388" y="71655"/>
              <a:chExt cx="10634065" cy="718936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B4DA843-A804-426A-9C4A-ED961A79178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3428" y="71655"/>
                <a:ext cx="4419600" cy="33147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1890A93-AB90-47C2-8BE8-C2C981617C5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596931" y="85803"/>
                <a:ext cx="4319547" cy="32396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2">
                <a:extLst>
                  <a:ext uri="{FF2B5EF4-FFF2-40B4-BE49-F238E27FC236}">
                    <a16:creationId xmlns:a16="http://schemas.microsoft.com/office/drawing/2014/main" id="{9893D9A1-6D97-4F49-A943-CF1D8D31602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38388" y="3677261"/>
                <a:ext cx="4419600" cy="33147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Picture 3">
                <a:extLst>
                  <a:ext uri="{FF2B5EF4-FFF2-40B4-BE49-F238E27FC236}">
                    <a16:creationId xmlns:a16="http://schemas.microsoft.com/office/drawing/2014/main" id="{19D7285C-89CE-4A0A-8DA8-D74D04888CF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76653" y="3480653"/>
                <a:ext cx="4495800" cy="3371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70FDEF3-1FCF-4722-A3F0-5324D514544F}"/>
                  </a:ext>
                </a:extLst>
              </p:cNvPr>
              <p:cNvSpPr txBox="1"/>
              <p:nvPr/>
            </p:nvSpPr>
            <p:spPr>
              <a:xfrm>
                <a:off x="3228783" y="3172878"/>
                <a:ext cx="44355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dirty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IN" sz="900" dirty="0" err="1">
                    <a:latin typeface="Times New Roman" pitchFamily="18" charset="0"/>
                    <a:cs typeface="Times New Roman" pitchFamily="18" charset="0"/>
                  </a:rPr>
                  <a:t>i</a:t>
                </a:r>
                <a:r>
                  <a:rPr lang="en-IN" sz="900" dirty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9263C36-2F51-481D-B73A-97B3196D8C91}"/>
                  </a:ext>
                </a:extLst>
              </p:cNvPr>
              <p:cNvSpPr txBox="1"/>
              <p:nvPr/>
            </p:nvSpPr>
            <p:spPr>
              <a:xfrm>
                <a:off x="9123499" y="3109356"/>
                <a:ext cx="44355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dirty="0">
                    <a:latin typeface="Times New Roman" pitchFamily="18" charset="0"/>
                    <a:cs typeface="Times New Roman" pitchFamily="18" charset="0"/>
                  </a:rPr>
                  <a:t>(ii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642AEB6A-E19D-499F-8DD8-970DA7F7F8A8}"/>
                  </a:ext>
                </a:extLst>
              </p:cNvPr>
              <p:cNvSpPr txBox="1"/>
              <p:nvPr/>
            </p:nvSpPr>
            <p:spPr>
              <a:xfrm>
                <a:off x="3433287" y="6953248"/>
                <a:ext cx="478095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dirty="0">
                    <a:latin typeface="Times New Roman" pitchFamily="18" charset="0"/>
                    <a:cs typeface="Times New Roman" pitchFamily="18" charset="0"/>
                  </a:rPr>
                  <a:t>(iii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30E41A0-A68F-4D9F-BD82-354775AF64E3}"/>
                  </a:ext>
                </a:extLst>
              </p:cNvPr>
              <p:cNvSpPr txBox="1"/>
              <p:nvPr/>
            </p:nvSpPr>
            <p:spPr>
              <a:xfrm>
                <a:off x="9345274" y="6684185"/>
                <a:ext cx="478095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dirty="0">
                    <a:latin typeface="Times New Roman" pitchFamily="18" charset="0"/>
                    <a:cs typeface="Times New Roman" pitchFamily="18" charset="0"/>
                  </a:rPr>
                  <a:t>(iv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32ADF52C-239B-4ACB-B95A-51D3960282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5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727624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E0ABCD3C-98F4-4E60-8F6F-F16D9FAE55D2}"/>
              </a:ext>
            </a:extLst>
          </p:cNvPr>
          <p:cNvGrpSpPr/>
          <p:nvPr/>
        </p:nvGrpSpPr>
        <p:grpSpPr>
          <a:xfrm>
            <a:off x="730301" y="1143000"/>
            <a:ext cx="7587527" cy="5095860"/>
            <a:chOff x="1001539" y="171526"/>
            <a:chExt cx="10116702" cy="6794480"/>
          </a:xfrm>
        </p:grpSpPr>
        <p:pic>
          <p:nvPicPr>
            <p:cNvPr id="6" name="Picture 2">
              <a:extLst>
                <a:ext uri="{FF2B5EF4-FFF2-40B4-BE49-F238E27FC236}">
                  <a16:creationId xmlns:a16="http://schemas.microsoft.com/office/drawing/2014/main" id="{F51D4EA8-6A31-4B31-9814-FBDEC9C3625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65942" y="171526"/>
              <a:ext cx="4343297" cy="32574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>
              <a:extLst>
                <a:ext uri="{FF2B5EF4-FFF2-40B4-BE49-F238E27FC236}">
                  <a16:creationId xmlns:a16="http://schemas.microsoft.com/office/drawing/2014/main" id="{D97A6EC3-B54C-46DE-9E36-6EFEA136AC5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22442" y="198341"/>
              <a:ext cx="4095916" cy="30719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2">
              <a:extLst>
                <a:ext uri="{FF2B5EF4-FFF2-40B4-BE49-F238E27FC236}">
                  <a16:creationId xmlns:a16="http://schemas.microsoft.com/office/drawing/2014/main" id="{B6FD4B88-9E1C-4E61-97A1-B50C8E217D4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65942" y="3600018"/>
              <a:ext cx="4267200" cy="320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>
              <a:extLst>
                <a:ext uri="{FF2B5EF4-FFF2-40B4-BE49-F238E27FC236}">
                  <a16:creationId xmlns:a16="http://schemas.microsoft.com/office/drawing/2014/main" id="{9AA80943-CE86-4E34-864D-29F5B9849C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22441" y="3511363"/>
              <a:ext cx="4495800" cy="33718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31BA6B5-DD0E-49F7-8A58-D9F27693A7BF}"/>
                </a:ext>
              </a:extLst>
            </p:cNvPr>
            <p:cNvSpPr txBox="1"/>
            <p:nvPr/>
          </p:nvSpPr>
          <p:spPr>
            <a:xfrm>
              <a:off x="1001539" y="304097"/>
              <a:ext cx="44355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CA0DE84-ED54-4A83-A238-5B7BE86B61B6}"/>
                </a:ext>
              </a:extLst>
            </p:cNvPr>
            <p:cNvSpPr txBox="1"/>
            <p:nvPr/>
          </p:nvSpPr>
          <p:spPr>
            <a:xfrm>
              <a:off x="3554831" y="3257981"/>
              <a:ext cx="44355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IN" sz="900" dirty="0" err="1">
                  <a:latin typeface="Times New Roman" pitchFamily="18" charset="0"/>
                  <a:cs typeface="Times New Roman" pitchFamily="18" charset="0"/>
                </a:rPr>
                <a:t>i</a:t>
              </a:r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519015D-F4A4-46D7-B118-A085305DDD56}"/>
                </a:ext>
              </a:extLst>
            </p:cNvPr>
            <p:cNvSpPr txBox="1"/>
            <p:nvPr/>
          </p:nvSpPr>
          <p:spPr>
            <a:xfrm>
              <a:off x="8906114" y="3157786"/>
              <a:ext cx="44355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B61C788-4640-472D-8A77-F4D8A142A604}"/>
                </a:ext>
              </a:extLst>
            </p:cNvPr>
            <p:cNvSpPr txBox="1"/>
            <p:nvPr/>
          </p:nvSpPr>
          <p:spPr>
            <a:xfrm>
              <a:off x="3740834" y="6575437"/>
              <a:ext cx="515099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E41E51B-4E71-4C5E-AEAB-43695FCC7C28}"/>
                </a:ext>
              </a:extLst>
            </p:cNvPr>
            <p:cNvSpPr txBox="1"/>
            <p:nvPr/>
          </p:nvSpPr>
          <p:spPr>
            <a:xfrm>
              <a:off x="9092117" y="6658230"/>
              <a:ext cx="515099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v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3214F18D-9B7E-48E9-A020-42D0D2B012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5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895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map&#10;&#10;Description automatically generated">
            <a:extLst>
              <a:ext uri="{FF2B5EF4-FFF2-40B4-BE49-F238E27FC236}">
                <a16:creationId xmlns:a16="http://schemas.microsoft.com/office/drawing/2014/main" id="{54F0D2DE-94BD-4D85-B71D-6786BC9363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" y="232620"/>
            <a:ext cx="8610600" cy="64176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0D9A542-67B3-47A2-B35C-8399D9F239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767" y="76200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1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1779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ACFF552F-1421-444A-9566-077C8B45C5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2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16" descr="A picture containing shape&#10;&#10;Description automatically generated">
            <a:extLst>
              <a:ext uri="{FF2B5EF4-FFF2-40B4-BE49-F238E27FC236}">
                <a16:creationId xmlns:a16="http://schemas.microsoft.com/office/drawing/2014/main" id="{B5641849-DAE8-457D-8A39-653BB92062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486" y="632549"/>
            <a:ext cx="8854561" cy="3942096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Table 22">
            <a:extLst>
              <a:ext uri="{FF2B5EF4-FFF2-40B4-BE49-F238E27FC236}">
                <a16:creationId xmlns:a16="http://schemas.microsoft.com/office/drawing/2014/main" id="{198DE447-B0AA-4D46-B141-EE4B9C0B03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4727550"/>
              </p:ext>
            </p:extLst>
          </p:nvPr>
        </p:nvGraphicFramePr>
        <p:xfrm>
          <a:off x="5893741" y="2743200"/>
          <a:ext cx="3196314" cy="25603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4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38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573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08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85800"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Multi-epitope constructs of SARS-CoV-2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No.</a:t>
                      </a:r>
                      <a:r>
                        <a:rPr lang="en-IN" sz="8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of residues in favoured region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No.</a:t>
                      </a:r>
                      <a:r>
                        <a:rPr lang="en-IN" sz="8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of residues in allowed region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No.</a:t>
                      </a:r>
                      <a:r>
                        <a:rPr lang="en-IN" sz="8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of residues in outlier region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(a) </a:t>
                      </a:r>
                      <a:r>
                        <a:rPr lang="en-IN" sz="800" dirty="0">
                          <a:latin typeface="Times New Roman" pitchFamily="18" charset="0"/>
                          <a:cs typeface="Times New Roman" pitchFamily="18" charset="0"/>
                        </a:rPr>
                        <a:t>RBD of spike protein (B- and T-cell epitopes)</a:t>
                      </a:r>
                      <a:endParaRPr lang="en-US" sz="8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184 (57.0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103 (31.9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36 (11.1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(b) </a:t>
                      </a:r>
                      <a:r>
                        <a:rPr lang="en-IN" sz="800" dirty="0">
                          <a:latin typeface="Times New Roman" pitchFamily="18" charset="0"/>
                          <a:cs typeface="Times New Roman" pitchFamily="18" charset="0"/>
                        </a:rPr>
                        <a:t>Spike protein (</a:t>
                      </a:r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B- and T-cell epitopes)</a:t>
                      </a:r>
                      <a:endParaRPr lang="en-US" sz="8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352 (72.4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93 (19.1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41 (8.4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(c)</a:t>
                      </a:r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 Structural protein construct </a:t>
                      </a:r>
                      <a:r>
                        <a:rPr lang="en-IN" sz="800" dirty="0">
                          <a:latin typeface="Times New Roman" pitchFamily="18" charset="0"/>
                          <a:cs typeface="Times New Roman" pitchFamily="18" charset="0"/>
                        </a:rPr>
                        <a:t>(B- and T-cell epitopes of S, N, M and E protein)</a:t>
                      </a:r>
                      <a:endParaRPr lang="en-US" sz="8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758 (68.8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226 (20.5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118 (10.7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Times New Roman" pitchFamily="18" charset="0"/>
                          <a:cs typeface="Times New Roman" pitchFamily="18" charset="0"/>
                        </a:rPr>
                        <a:t>(d)</a:t>
                      </a:r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 Chimeric construct of S and N proteins (</a:t>
                      </a:r>
                      <a:r>
                        <a:rPr lang="en-IN" sz="800" dirty="0">
                          <a:latin typeface="Times New Roman" pitchFamily="18" charset="0"/>
                          <a:cs typeface="Times New Roman" pitchFamily="18" charset="0"/>
                        </a:rPr>
                        <a:t>B- and T-cell epitopes of S and N)</a:t>
                      </a:r>
                      <a:endParaRPr lang="en-US" sz="800" b="1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695 (83.0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102 (12.2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800" b="1" dirty="0">
                          <a:latin typeface="Times New Roman" pitchFamily="18" charset="0"/>
                          <a:cs typeface="Times New Roman" pitchFamily="18" charset="0"/>
                        </a:rPr>
                        <a:t>40 (4.8%)</a:t>
                      </a:r>
                      <a:endParaRPr lang="en-US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BE13C1FA-2556-4551-A5AD-779412E1B275}"/>
              </a:ext>
            </a:extLst>
          </p:cNvPr>
          <p:cNvGrpSpPr/>
          <p:nvPr/>
        </p:nvGrpSpPr>
        <p:grpSpPr>
          <a:xfrm>
            <a:off x="381000" y="76200"/>
            <a:ext cx="5514909" cy="6707832"/>
            <a:chOff x="1067489" y="629337"/>
            <a:chExt cx="4527688" cy="4383466"/>
          </a:xfrm>
        </p:grpSpPr>
        <p:pic>
          <p:nvPicPr>
            <p:cNvPr id="4" name="Picture 2" descr="I:\SARS-CoV2\Results\6. Multi-epitope construct\Ramachandran Plot\Con2.png"/>
            <p:cNvPicPr>
              <a:picLocks noChangeAspect="1" noChangeArrowheads="1"/>
            </p:cNvPicPr>
            <p:nvPr/>
          </p:nvPicPr>
          <p:blipFill>
            <a:blip r:embed="rId2" cstate="print"/>
            <a:srcRect l="10672" t="17921" r="8655" b="25776"/>
            <a:stretch>
              <a:fillRect/>
            </a:stretch>
          </p:blipFill>
          <p:spPr bwMode="auto">
            <a:xfrm>
              <a:off x="3400486" y="629337"/>
              <a:ext cx="2194691" cy="2167259"/>
            </a:xfrm>
            <a:prstGeom prst="rect">
              <a:avLst/>
            </a:prstGeom>
            <a:noFill/>
          </p:spPr>
        </p:pic>
        <p:pic>
          <p:nvPicPr>
            <p:cNvPr id="9" name="Picture 2" descr="I:\SARS-CoV2\Results\6. Multi-epitope construct\Ramachandran Plot\Con3.png"/>
            <p:cNvPicPr>
              <a:picLocks noChangeAspect="1" noChangeArrowheads="1"/>
            </p:cNvPicPr>
            <p:nvPr/>
          </p:nvPicPr>
          <p:blipFill>
            <a:blip r:embed="rId3"/>
            <a:srcRect l="9649" t="17931" r="3574" b="25783"/>
            <a:stretch>
              <a:fillRect/>
            </a:stretch>
          </p:blipFill>
          <p:spPr bwMode="auto">
            <a:xfrm>
              <a:off x="1104901" y="2911503"/>
              <a:ext cx="2177488" cy="2000250"/>
            </a:xfrm>
            <a:prstGeom prst="rect">
              <a:avLst/>
            </a:prstGeom>
            <a:noFill/>
          </p:spPr>
        </p:pic>
        <p:sp>
          <p:nvSpPr>
            <p:cNvPr id="11" name="TextBox 10"/>
            <p:cNvSpPr txBox="1"/>
            <p:nvPr/>
          </p:nvSpPr>
          <p:spPr>
            <a:xfrm>
              <a:off x="4037299" y="2670954"/>
              <a:ext cx="288312" cy="150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37323" y="4860499"/>
              <a:ext cx="342900" cy="150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37323" y="2769087"/>
              <a:ext cx="332664" cy="150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a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82736" y="4861958"/>
              <a:ext cx="285750" cy="1508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1" name="Picture 2" descr="I:\SARS-CoV2\Results\6. Multi-epitope construct\Ramachandran Plot\Con4.png"/>
            <p:cNvPicPr>
              <a:picLocks noChangeAspect="1" noChangeArrowheads="1"/>
            </p:cNvPicPr>
            <p:nvPr/>
          </p:nvPicPr>
          <p:blipFill>
            <a:blip r:embed="rId4" cstate="print"/>
            <a:srcRect l="9664" t="17921" r="5630" b="25841"/>
            <a:stretch>
              <a:fillRect/>
            </a:stretch>
          </p:blipFill>
          <p:spPr bwMode="auto">
            <a:xfrm>
              <a:off x="3431409" y="2870136"/>
              <a:ext cx="2161988" cy="2030958"/>
            </a:xfrm>
            <a:prstGeom prst="rect">
              <a:avLst/>
            </a:prstGeom>
            <a:noFill/>
          </p:spPr>
        </p:pic>
        <p:pic>
          <p:nvPicPr>
            <p:cNvPr id="24" name="Picture 3" descr="I:\SARS-CoV2\Results\6. Multi-epitope construct\Ramachandran Plot\Con1New_2.png">
              <a:extLst>
                <a:ext uri="{FF2B5EF4-FFF2-40B4-BE49-F238E27FC236}">
                  <a16:creationId xmlns:a16="http://schemas.microsoft.com/office/drawing/2014/main" id="{1C1E71E5-0165-448A-BAE3-F2A88D0ABB7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067489" y="629337"/>
              <a:ext cx="2332228" cy="2167259"/>
            </a:xfrm>
            <a:prstGeom prst="rect">
              <a:avLst/>
            </a:prstGeom>
            <a:noFill/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31FEB253-80A6-4A93-94F3-DC8619992A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76200" y="228600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3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1FCB041-B029-4521-AC52-60DB0ABB35BF}"/>
              </a:ext>
            </a:extLst>
          </p:cNvPr>
          <p:cNvGrpSpPr/>
          <p:nvPr/>
        </p:nvGrpSpPr>
        <p:grpSpPr>
          <a:xfrm>
            <a:off x="4648200" y="457200"/>
            <a:ext cx="4392042" cy="5410200"/>
            <a:chOff x="4648200" y="457200"/>
            <a:chExt cx="4392042" cy="5410200"/>
          </a:xfrm>
        </p:grpSpPr>
        <p:sp>
          <p:nvSpPr>
            <p:cNvPr id="5" name="TextBox 4"/>
            <p:cNvSpPr txBox="1"/>
            <p:nvPr/>
          </p:nvSpPr>
          <p:spPr>
            <a:xfrm>
              <a:off x="4648200" y="533400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27" name="Picture 3" descr="I:\SARS-CoV2\Results\6. Multi-epitope construct\Secondary Structure\Con2_psipredChart.png"/>
            <p:cNvPicPr>
              <a:picLocks noChangeAspect="1" noChangeArrowheads="1"/>
            </p:cNvPicPr>
            <p:nvPr/>
          </p:nvPicPr>
          <p:blipFill>
            <a:blip r:embed="rId2" cstate="print"/>
            <a:srcRect r="5000" b="16396"/>
            <a:stretch>
              <a:fillRect/>
            </a:stretch>
          </p:blipFill>
          <p:spPr bwMode="auto">
            <a:xfrm>
              <a:off x="5048250" y="457200"/>
              <a:ext cx="3991992" cy="5410200"/>
            </a:xfrm>
            <a:prstGeom prst="rect">
              <a:avLst/>
            </a:prstGeom>
            <a:noFill/>
          </p:spPr>
        </p:pic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54CDD120-B08B-4090-947F-E587BAAC7711}"/>
              </a:ext>
            </a:extLst>
          </p:cNvPr>
          <p:cNvGrpSpPr/>
          <p:nvPr/>
        </p:nvGrpSpPr>
        <p:grpSpPr>
          <a:xfrm>
            <a:off x="59786" y="638032"/>
            <a:ext cx="4716050" cy="3886200"/>
            <a:chOff x="59786" y="638032"/>
            <a:chExt cx="4716050" cy="3886200"/>
          </a:xfrm>
        </p:grpSpPr>
        <p:pic>
          <p:nvPicPr>
            <p:cNvPr id="9" name="Picture 3" descr="I:\SARS-CoV2\Results\6. Multi-epitope construct\Secondary Structure\Con1New_psipredChart_2.png">
              <a:extLst>
                <a:ext uri="{FF2B5EF4-FFF2-40B4-BE49-F238E27FC236}">
                  <a16:creationId xmlns:a16="http://schemas.microsoft.com/office/drawing/2014/main" id="{D8C818DC-CC87-418B-9A05-FEA6C8E8E42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16986" y="638032"/>
              <a:ext cx="4258850" cy="3886200"/>
            </a:xfrm>
            <a:prstGeom prst="rect">
              <a:avLst/>
            </a:prstGeom>
            <a:noFill/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26FC934-CDD1-46C1-823F-0A65F78FB034}"/>
                </a:ext>
              </a:extLst>
            </p:cNvPr>
            <p:cNvSpPr txBox="1"/>
            <p:nvPr/>
          </p:nvSpPr>
          <p:spPr>
            <a:xfrm>
              <a:off x="59786" y="793466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(a)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988AB67B-2705-4599-8F88-8DFC022A57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4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D5F4143-A899-49B2-AE54-E3D927036B6D}"/>
              </a:ext>
            </a:extLst>
          </p:cNvPr>
          <p:cNvGrpSpPr/>
          <p:nvPr/>
        </p:nvGrpSpPr>
        <p:grpSpPr>
          <a:xfrm>
            <a:off x="533400" y="173567"/>
            <a:ext cx="8305800" cy="6591300"/>
            <a:chOff x="457200" y="177364"/>
            <a:chExt cx="8305800" cy="6591300"/>
          </a:xfrm>
        </p:grpSpPr>
        <p:pic>
          <p:nvPicPr>
            <p:cNvPr id="2050" name="Picture 2" descr="I:\SARS-CoV2\Results\6. Multi-epitope construct\Secondary Structure\Con3_psipredChart.png"/>
            <p:cNvPicPr>
              <a:picLocks noChangeAspect="1" noChangeArrowheads="1"/>
            </p:cNvPicPr>
            <p:nvPr/>
          </p:nvPicPr>
          <p:blipFill>
            <a:blip r:embed="rId2" cstate="print"/>
            <a:srcRect b="47917"/>
            <a:stretch>
              <a:fillRect/>
            </a:stretch>
          </p:blipFill>
          <p:spPr bwMode="auto">
            <a:xfrm>
              <a:off x="805543" y="177364"/>
              <a:ext cx="3766457" cy="6591300"/>
            </a:xfrm>
            <a:prstGeom prst="rect">
              <a:avLst/>
            </a:prstGeom>
            <a:noFill/>
          </p:spPr>
        </p:pic>
        <p:pic>
          <p:nvPicPr>
            <p:cNvPr id="4" name="Picture 2" descr="I:\SARS-CoV2\Results\6. Multi-epitope construct\Secondary Structure\Con3_psipredChart.png"/>
            <p:cNvPicPr>
              <a:picLocks noChangeAspect="1" noChangeArrowheads="1"/>
            </p:cNvPicPr>
            <p:nvPr/>
          </p:nvPicPr>
          <p:blipFill>
            <a:blip r:embed="rId3" cstate="print"/>
            <a:srcRect t="51637" b="1095"/>
            <a:stretch>
              <a:fillRect/>
            </a:stretch>
          </p:blipFill>
          <p:spPr bwMode="auto">
            <a:xfrm>
              <a:off x="4876800" y="228600"/>
              <a:ext cx="3886200" cy="6172200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457200" y="228600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IN" sz="1200" b="1" dirty="0">
                  <a:latin typeface="Times New Roman" pitchFamily="18" charset="0"/>
                  <a:cs typeface="Times New Roman" pitchFamily="18" charset="0"/>
                </a:rPr>
                <a:t>c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1AECF481-F54D-4DA4-A542-880A3D194C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41" y="22828"/>
            <a:ext cx="731918" cy="4039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4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9DF5A53-0F18-4136-B78E-29BA38773C04}"/>
              </a:ext>
            </a:extLst>
          </p:cNvPr>
          <p:cNvGrpSpPr/>
          <p:nvPr/>
        </p:nvGrpSpPr>
        <p:grpSpPr>
          <a:xfrm>
            <a:off x="128650" y="762000"/>
            <a:ext cx="9015350" cy="5181600"/>
            <a:chOff x="128650" y="762000"/>
            <a:chExt cx="9015350" cy="5181600"/>
          </a:xfrm>
        </p:grpSpPr>
        <p:pic>
          <p:nvPicPr>
            <p:cNvPr id="3075" name="Picture 3" descr="I:\SARS-CoV2\Results\6. Multi-epitope construct\Secondary Structure\Con4_psipredChart.png"/>
            <p:cNvPicPr>
              <a:picLocks noChangeAspect="1" noChangeArrowheads="1"/>
            </p:cNvPicPr>
            <p:nvPr/>
          </p:nvPicPr>
          <p:blipFill>
            <a:blip r:embed="rId2" cstate="print"/>
            <a:srcRect b="48097"/>
            <a:stretch>
              <a:fillRect/>
            </a:stretch>
          </p:blipFill>
          <p:spPr bwMode="auto">
            <a:xfrm>
              <a:off x="609600" y="762000"/>
              <a:ext cx="3961573" cy="5181600"/>
            </a:xfrm>
            <a:prstGeom prst="rect">
              <a:avLst/>
            </a:prstGeom>
            <a:noFill/>
          </p:spPr>
        </p:pic>
        <p:pic>
          <p:nvPicPr>
            <p:cNvPr id="7" name="Picture 3" descr="I:\SARS-CoV2\Results\6. Multi-epitope construct\Secondary Structure\Con4_psipredChart.png"/>
            <p:cNvPicPr>
              <a:picLocks noChangeAspect="1" noChangeArrowheads="1"/>
            </p:cNvPicPr>
            <p:nvPr/>
          </p:nvPicPr>
          <p:blipFill>
            <a:blip r:embed="rId3"/>
            <a:srcRect t="51381" b="3241"/>
            <a:stretch>
              <a:fillRect/>
            </a:stretch>
          </p:blipFill>
          <p:spPr bwMode="auto">
            <a:xfrm>
              <a:off x="4945944" y="838200"/>
              <a:ext cx="4198056" cy="4800600"/>
            </a:xfrm>
            <a:prstGeom prst="rect">
              <a:avLst/>
            </a:prstGeom>
            <a:noFill/>
          </p:spPr>
        </p:pic>
        <p:sp>
          <p:nvSpPr>
            <p:cNvPr id="8" name="TextBox 7"/>
            <p:cNvSpPr txBox="1"/>
            <p:nvPr/>
          </p:nvSpPr>
          <p:spPr>
            <a:xfrm>
              <a:off x="128650" y="782876"/>
              <a:ext cx="4197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IN" sz="1200" b="1" dirty="0">
                  <a:latin typeface="Times New Roman" pitchFamily="18" charset="0"/>
                  <a:cs typeface="Times New Roman" pitchFamily="18" charset="0"/>
                </a:rPr>
                <a:t>d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10" name="Picture 9" descr="I:\SARS-CoV2\Results\6. Multi-epitope construct\Secondary Structure\Con1_psipredChart.png">
            <a:extLst>
              <a:ext uri="{FF2B5EF4-FFF2-40B4-BE49-F238E27FC236}">
                <a16:creationId xmlns:a16="http://schemas.microsoft.com/office/drawing/2014/main" id="{E9929503-8FC3-49AB-A071-CA876E43CF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 t="78689" r="43541" b="11475"/>
          <a:stretch>
            <a:fillRect/>
          </a:stretch>
        </p:blipFill>
        <p:spPr bwMode="auto">
          <a:xfrm>
            <a:off x="5181600" y="5943600"/>
            <a:ext cx="3124200" cy="4572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A10EEC4-0A56-40E3-B521-5BDFB5A74F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4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0A58C15-139D-4022-9D0C-1778A21A0B37}"/>
              </a:ext>
            </a:extLst>
          </p:cNvPr>
          <p:cNvGrpSpPr/>
          <p:nvPr/>
        </p:nvGrpSpPr>
        <p:grpSpPr>
          <a:xfrm>
            <a:off x="609600" y="685800"/>
            <a:ext cx="7499378" cy="5167274"/>
            <a:chOff x="482589" y="884540"/>
            <a:chExt cx="7499378" cy="5167274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FBAFB5FF-E9B6-4251-B09A-96CBCA84096F}"/>
                </a:ext>
              </a:extLst>
            </p:cNvPr>
            <p:cNvGrpSpPr/>
            <p:nvPr/>
          </p:nvGrpSpPr>
          <p:grpSpPr>
            <a:xfrm>
              <a:off x="482589" y="884540"/>
              <a:ext cx="7499378" cy="5079148"/>
              <a:chOff x="267731" y="123110"/>
              <a:chExt cx="9999170" cy="6772198"/>
            </a:xfrm>
          </p:grpSpPr>
          <p:pic>
            <p:nvPicPr>
              <p:cNvPr id="2" name="Picture 2">
                <a:extLst>
                  <a:ext uri="{FF2B5EF4-FFF2-40B4-BE49-F238E27FC236}">
                    <a16:creationId xmlns:a16="http://schemas.microsoft.com/office/drawing/2014/main" id="{1F239F63-5C28-49FC-A4AC-437017DA5B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100" y="123110"/>
                <a:ext cx="4591347" cy="34435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" name="Picture 3">
                <a:extLst>
                  <a:ext uri="{FF2B5EF4-FFF2-40B4-BE49-F238E27FC236}">
                    <a16:creationId xmlns:a16="http://schemas.microsoft.com/office/drawing/2014/main" id="{2C2AB059-5645-409D-A26C-EF242737DE3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27422" y="180059"/>
                <a:ext cx="4439479" cy="33296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Picture 2">
                <a:extLst>
                  <a:ext uri="{FF2B5EF4-FFF2-40B4-BE49-F238E27FC236}">
                    <a16:creationId xmlns:a16="http://schemas.microsoft.com/office/drawing/2014/main" id="{789FBBF5-ADBA-49E9-A4EA-1A88AD7E1DE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85112" y="3652236"/>
                <a:ext cx="4324096" cy="324307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" name="Picture 3">
                <a:extLst>
                  <a:ext uri="{FF2B5EF4-FFF2-40B4-BE49-F238E27FC236}">
                    <a16:creationId xmlns:a16="http://schemas.microsoft.com/office/drawing/2014/main" id="{40A976B7-7806-4817-8902-8223F239F75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3629" y="3529312"/>
                <a:ext cx="4439479" cy="33296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CD9FB0E-4931-4E97-8BD8-EFFB15904D1B}"/>
                  </a:ext>
                </a:extLst>
              </p:cNvPr>
              <p:cNvSpPr txBox="1"/>
              <p:nvPr/>
            </p:nvSpPr>
            <p:spPr>
              <a:xfrm>
                <a:off x="267731" y="142751"/>
                <a:ext cx="636739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itchFamily="18" charset="0"/>
                    <a:cs typeface="Times New Roman" pitchFamily="18" charset="0"/>
                  </a:rPr>
                  <a:t>(a)</a:t>
                </a:r>
                <a:endParaRPr 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A9910FC-940C-4C25-B290-AFE76FEB7E46}"/>
                </a:ext>
              </a:extLst>
            </p:cNvPr>
            <p:cNvSpPr txBox="1"/>
            <p:nvPr/>
          </p:nvSpPr>
          <p:spPr>
            <a:xfrm>
              <a:off x="2601816" y="3320584"/>
              <a:ext cx="332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IN" sz="900" dirty="0" err="1">
                  <a:latin typeface="Times New Roman" pitchFamily="18" charset="0"/>
                  <a:cs typeface="Times New Roman" pitchFamily="18" charset="0"/>
                </a:rPr>
                <a:t>i</a:t>
              </a:r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9EB9B11-EB69-4F3C-9596-5B19041EB62D}"/>
                </a:ext>
              </a:extLst>
            </p:cNvPr>
            <p:cNvSpPr txBox="1"/>
            <p:nvPr/>
          </p:nvSpPr>
          <p:spPr>
            <a:xfrm>
              <a:off x="6412539" y="3302694"/>
              <a:ext cx="332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3603FB0-37C7-4DB0-B159-B11364EAC8F3}"/>
                </a:ext>
              </a:extLst>
            </p:cNvPr>
            <p:cNvSpPr txBox="1"/>
            <p:nvPr/>
          </p:nvSpPr>
          <p:spPr>
            <a:xfrm>
              <a:off x="2934480" y="5820982"/>
              <a:ext cx="418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D1115BC-D63D-4CA0-B855-B267F6388F35}"/>
                </a:ext>
              </a:extLst>
            </p:cNvPr>
            <p:cNvSpPr txBox="1"/>
            <p:nvPr/>
          </p:nvSpPr>
          <p:spPr>
            <a:xfrm>
              <a:off x="6591255" y="5819767"/>
              <a:ext cx="418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v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46C1892F-B6C9-43DF-86B2-35BAC17CD3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5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87626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5187CA3-0E9E-426E-AEAB-444166AFD5BD}"/>
              </a:ext>
            </a:extLst>
          </p:cNvPr>
          <p:cNvGrpSpPr/>
          <p:nvPr/>
        </p:nvGrpSpPr>
        <p:grpSpPr>
          <a:xfrm>
            <a:off x="491524" y="685800"/>
            <a:ext cx="7174893" cy="4888850"/>
            <a:chOff x="228600" y="991192"/>
            <a:chExt cx="7174893" cy="4888850"/>
          </a:xfrm>
        </p:grpSpPr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id="{FBCD1DDC-CFFC-4F2F-8060-7C683CFAC7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4355" y="991192"/>
              <a:ext cx="3143250" cy="23574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>
              <a:extLst>
                <a:ext uri="{FF2B5EF4-FFF2-40B4-BE49-F238E27FC236}">
                  <a16:creationId xmlns:a16="http://schemas.microsoft.com/office/drawing/2014/main" id="{6026BE00-1CB9-42DE-91ED-3119D343B09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00608" y="1064406"/>
              <a:ext cx="3057641" cy="2293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2">
              <a:extLst>
                <a:ext uri="{FF2B5EF4-FFF2-40B4-BE49-F238E27FC236}">
                  <a16:creationId xmlns:a16="http://schemas.microsoft.com/office/drawing/2014/main" id="{C30D7A9F-769C-4C6B-BB7E-BBFFA00656B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881" y="3518377"/>
              <a:ext cx="2971800" cy="22288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>
              <a:extLst>
                <a:ext uri="{FF2B5EF4-FFF2-40B4-BE49-F238E27FC236}">
                  <a16:creationId xmlns:a16="http://schemas.microsoft.com/office/drawing/2014/main" id="{0FB107F4-AD38-4C57-BBA8-989A6908FE2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0243" y="3357637"/>
              <a:ext cx="3143250" cy="23574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470DA1A-9CC7-4CFE-BBB6-BC6B24883306}"/>
                </a:ext>
              </a:extLst>
            </p:cNvPr>
            <p:cNvSpPr txBox="1"/>
            <p:nvPr/>
          </p:nvSpPr>
          <p:spPr>
            <a:xfrm>
              <a:off x="228600" y="1000199"/>
              <a:ext cx="3881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B5CE03-A628-4A97-9A49-7CB58E7CC7B7}"/>
                </a:ext>
              </a:extLst>
            </p:cNvPr>
            <p:cNvSpPr txBox="1"/>
            <p:nvPr/>
          </p:nvSpPr>
          <p:spPr>
            <a:xfrm>
              <a:off x="2090285" y="3253902"/>
              <a:ext cx="332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IN" sz="900" dirty="0" err="1">
                  <a:latin typeface="Times New Roman" pitchFamily="18" charset="0"/>
                  <a:cs typeface="Times New Roman" pitchFamily="18" charset="0"/>
                </a:rPr>
                <a:t>i</a:t>
              </a:r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DBFC472-21DE-40A7-AF49-B57586E76D32}"/>
                </a:ext>
              </a:extLst>
            </p:cNvPr>
            <p:cNvSpPr txBox="1"/>
            <p:nvPr/>
          </p:nvSpPr>
          <p:spPr>
            <a:xfrm>
              <a:off x="5901006" y="3236012"/>
              <a:ext cx="332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8355470-F866-4AB2-9A9B-810BC82B4C2B}"/>
                </a:ext>
              </a:extLst>
            </p:cNvPr>
            <p:cNvSpPr txBox="1"/>
            <p:nvPr/>
          </p:nvSpPr>
          <p:spPr>
            <a:xfrm>
              <a:off x="2256617" y="5649210"/>
              <a:ext cx="395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ii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A09A359-C7AF-4A6F-BFB9-A202936613B1}"/>
                </a:ext>
              </a:extLst>
            </p:cNvPr>
            <p:cNvSpPr txBox="1"/>
            <p:nvPr/>
          </p:nvSpPr>
          <p:spPr>
            <a:xfrm>
              <a:off x="5966416" y="5598404"/>
              <a:ext cx="395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dirty="0">
                  <a:latin typeface="Times New Roman" pitchFamily="18" charset="0"/>
                  <a:cs typeface="Times New Roman" pitchFamily="18" charset="0"/>
                </a:rPr>
                <a:t>(iv)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3E658D0F-3BCE-4F77-BC92-D4925CE913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953" y="223517"/>
            <a:ext cx="731918" cy="40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S5</a:t>
            </a: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0538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06</TotalTime>
  <Words>453</Words>
  <Application>Microsoft Office PowerPoint</Application>
  <PresentationFormat>On-screen Show (4:3)</PresentationFormat>
  <Paragraphs>109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ma</dc:creator>
  <cp:lastModifiedBy>Nima D Namsa</cp:lastModifiedBy>
  <cp:revision>160</cp:revision>
  <dcterms:created xsi:type="dcterms:W3CDTF">2006-08-16T00:00:00Z</dcterms:created>
  <dcterms:modified xsi:type="dcterms:W3CDTF">2020-12-30T18:09:19Z</dcterms:modified>
</cp:coreProperties>
</file>